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8" d="100"/>
          <a:sy n="88" d="100"/>
        </p:scale>
        <p:origin x="451" y="6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2C74B-C205-466C-9216-C01F9F6C1D2D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B1FF1-CE65-427A-AAC2-72D26359AF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22147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2C74B-C205-466C-9216-C01F9F6C1D2D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B1FF1-CE65-427A-AAC2-72D26359AF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20954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2C74B-C205-466C-9216-C01F9F6C1D2D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B1FF1-CE65-427A-AAC2-72D26359AF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16714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2C74B-C205-466C-9216-C01F9F6C1D2D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B1FF1-CE65-427A-AAC2-72D26359AF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1189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2C74B-C205-466C-9216-C01F9F6C1D2D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B1FF1-CE65-427A-AAC2-72D26359AF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46754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2C74B-C205-466C-9216-C01F9F6C1D2D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B1FF1-CE65-427A-AAC2-72D26359AF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90346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2C74B-C205-466C-9216-C01F9F6C1D2D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B1FF1-CE65-427A-AAC2-72D26359AF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1830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2C74B-C205-466C-9216-C01F9F6C1D2D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B1FF1-CE65-427A-AAC2-72D26359AF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50660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2C74B-C205-466C-9216-C01F9F6C1D2D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B1FF1-CE65-427A-AAC2-72D26359AF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20167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2C74B-C205-466C-9216-C01F9F6C1D2D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B1FF1-CE65-427A-AAC2-72D26359AF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61142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2C74B-C205-466C-9216-C01F9F6C1D2D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B1FF1-CE65-427A-AAC2-72D26359AF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44826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32C74B-C205-466C-9216-C01F9F6C1D2D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BB1FF1-CE65-427A-AAC2-72D26359AF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40331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086"/>
          <a:stretch/>
        </p:blipFill>
        <p:spPr>
          <a:xfrm>
            <a:off x="864869" y="370174"/>
            <a:ext cx="4236520" cy="27432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581"/>
          <a:stretch/>
        </p:blipFill>
        <p:spPr>
          <a:xfrm>
            <a:off x="923066" y="3704006"/>
            <a:ext cx="4070039" cy="27432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5342"/>
          <a:stretch/>
        </p:blipFill>
        <p:spPr>
          <a:xfrm>
            <a:off x="5844193" y="353599"/>
            <a:ext cx="4033734" cy="27432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4656835" y="6480355"/>
            <a:ext cx="1945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/>
              <a:t>Heatmap</a:t>
            </a:r>
            <a:r>
              <a:rPr lang="en-US" b="1" dirty="0" smtClean="0"/>
              <a:t> for </a:t>
            </a:r>
            <a:r>
              <a:rPr lang="en-US" b="1" dirty="0" err="1" smtClean="0"/>
              <a:t>tRNA</a:t>
            </a:r>
            <a:endParaRPr lang="en-US" b="1" dirty="0"/>
          </a:p>
        </p:txBody>
      </p:sp>
      <p:sp>
        <p:nvSpPr>
          <p:cNvPr id="2" name="Rectangle 1"/>
          <p:cNvSpPr/>
          <p:nvPr/>
        </p:nvSpPr>
        <p:spPr>
          <a:xfrm>
            <a:off x="1435659" y="29248"/>
            <a:ext cx="278505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u="sng" dirty="0"/>
              <a:t>Non-smokers vs. Cigarette smokers</a:t>
            </a:r>
          </a:p>
        </p:txBody>
      </p:sp>
      <p:sp>
        <p:nvSpPr>
          <p:cNvPr id="3" name="Rectangle 2"/>
          <p:cNvSpPr/>
          <p:nvPr/>
        </p:nvSpPr>
        <p:spPr>
          <a:xfrm>
            <a:off x="6429408" y="29248"/>
            <a:ext cx="289912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u="sng" dirty="0"/>
              <a:t>Non-smokers vs. </a:t>
            </a:r>
            <a:r>
              <a:rPr lang="en-US" sz="1400" b="1" u="sng" dirty="0" err="1"/>
              <a:t>Waterpipe</a:t>
            </a:r>
            <a:r>
              <a:rPr lang="en-US" sz="1400" b="1" u="sng" dirty="0"/>
              <a:t> smokers</a:t>
            </a:r>
          </a:p>
        </p:txBody>
      </p:sp>
      <p:sp>
        <p:nvSpPr>
          <p:cNvPr id="9" name="Rectangle 8"/>
          <p:cNvSpPr/>
          <p:nvPr/>
        </p:nvSpPr>
        <p:spPr>
          <a:xfrm>
            <a:off x="1597081" y="3267262"/>
            <a:ext cx="22347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u="sng" dirty="0"/>
              <a:t>Non-smokers vs. E-cig </a:t>
            </a:r>
            <a:r>
              <a:rPr lang="en-US" sz="1400" b="1" u="sng" dirty="0" smtClean="0"/>
              <a:t>users</a:t>
            </a:r>
            <a:endParaRPr lang="en-US" sz="1400" b="1" u="sng" dirty="0"/>
          </a:p>
        </p:txBody>
      </p:sp>
      <p:sp>
        <p:nvSpPr>
          <p:cNvPr id="10" name="Rectangle 9"/>
          <p:cNvSpPr/>
          <p:nvPr/>
        </p:nvSpPr>
        <p:spPr>
          <a:xfrm>
            <a:off x="6724165" y="3271640"/>
            <a:ext cx="245740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u="sng" dirty="0"/>
              <a:t>Non-smokers vs. </a:t>
            </a:r>
            <a:r>
              <a:rPr lang="en-US" sz="1400" b="1" u="sng" smtClean="0"/>
              <a:t>Dual </a:t>
            </a:r>
            <a:r>
              <a:rPr lang="en-US" sz="1400" b="1" u="sng" dirty="0"/>
              <a:t>smokers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072695" y="8312"/>
            <a:ext cx="512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.</a:t>
            </a:r>
            <a:endParaRPr lang="en-US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6071685" y="8312"/>
            <a:ext cx="5008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.</a:t>
            </a:r>
            <a:endParaRPr lang="en-US" b="1" dirty="0"/>
          </a:p>
        </p:txBody>
      </p:sp>
      <p:sp>
        <p:nvSpPr>
          <p:cNvPr id="13" name="TextBox 12"/>
          <p:cNvSpPr txBox="1"/>
          <p:nvPr/>
        </p:nvSpPr>
        <p:spPr>
          <a:xfrm flipH="1">
            <a:off x="1135202" y="3242341"/>
            <a:ext cx="3875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.</a:t>
            </a:r>
            <a:endParaRPr lang="en-US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6126480" y="3255118"/>
            <a:ext cx="5478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D.</a:t>
            </a:r>
            <a:endParaRPr lang="en-US" b="1" dirty="0"/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6254"/>
          <a:stretch/>
        </p:blipFill>
        <p:spPr>
          <a:xfrm>
            <a:off x="5844193" y="3611673"/>
            <a:ext cx="4033734" cy="2881125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-57150" y="-27902"/>
            <a:ext cx="137050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u="sng" dirty="0"/>
              <a:t>Suppl. </a:t>
            </a:r>
            <a:r>
              <a:rPr lang="en-US" sz="1400" b="1" u="sng"/>
              <a:t>Figure </a:t>
            </a:r>
            <a:r>
              <a:rPr lang="en-US" sz="1400" b="1" u="sng" dirty="0"/>
              <a:t>7</a:t>
            </a:r>
            <a:r>
              <a:rPr lang="en-US" sz="1400" b="1" smtClean="0"/>
              <a:t>. 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7126652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36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R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ngh, Kameshwar</dc:creator>
  <cp:lastModifiedBy>Rahman, Irfan</cp:lastModifiedBy>
  <cp:revision>11</cp:revision>
  <dcterms:created xsi:type="dcterms:W3CDTF">2019-12-08T17:18:47Z</dcterms:created>
  <dcterms:modified xsi:type="dcterms:W3CDTF">2020-06-12T05:18:19Z</dcterms:modified>
</cp:coreProperties>
</file>